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BEA42-29ED-47AC-9EC8-F074D05BB5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80058-498F-403A-8718-1FC61A6E23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7428D-3681-417D-9757-457F10FB9D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528AC-6F9F-411A-B0A8-C84D615B12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B22EE-81E3-4723-8482-BB7423EE47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248F6-9C5A-4FF5-B17F-D849E4CB06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F6E39-E16A-426A-B943-5932119FB7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0168B-C842-4032-9E33-34AD70CCCB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5E5D5-AC4B-4386-A918-C83CA65888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4C749-3E6C-42FA-B0A2-8D6C6439CE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B20D7-7F8A-4CBE-B573-2C572D0D94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920DC-F452-46B8-A0C1-2F50F1205B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1014AD2-DDCF-4A05-AEE7-EADB63183527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AF80C6D-12A2-46D9-A343-0179655FF7B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1770840" y="17640"/>
            <a:ext cx="483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#1:  Clustal alignment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agin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across Hymenopter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6"/>
          <p:cNvGrpSpPr/>
          <p:nvPr/>
        </p:nvGrpSpPr>
        <p:grpSpPr>
          <a:xfrm>
            <a:off x="2197080" y="293760"/>
            <a:ext cx="4749840" cy="6234120"/>
            <a:chOff x="2197080" y="293760"/>
            <a:chExt cx="4749840" cy="6234120"/>
          </a:xfrm>
        </p:grpSpPr>
        <p:pic>
          <p:nvPicPr>
            <p:cNvPr id="43" name="Picture 3" descr=""/>
            <p:cNvPicPr/>
            <p:nvPr/>
          </p:nvPicPr>
          <p:blipFill>
            <a:blip r:embed="rId1"/>
            <a:stretch/>
          </p:blipFill>
          <p:spPr>
            <a:xfrm>
              <a:off x="2197080" y="293760"/>
              <a:ext cx="4749840" cy="6234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Rectangle 4"/>
            <p:cNvSpPr/>
            <p:nvPr/>
          </p:nvSpPr>
          <p:spPr>
            <a:xfrm>
              <a:off x="5450040" y="2700360"/>
              <a:ext cx="152280" cy="525240"/>
            </a:xfrm>
            <a:prstGeom prst="rect">
              <a:avLst/>
            </a:prstGeom>
            <a:noFill/>
            <a:ln w="28440">
              <a:solidFill>
                <a:srgbClr val="4a7ebb"/>
              </a:solidFill>
              <a:round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"/>
          <p:cNvSpPr/>
          <p:nvPr/>
        </p:nvSpPr>
        <p:spPr>
          <a:xfrm>
            <a:off x="1539000" y="4452840"/>
            <a:ext cx="456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ue boxes indicate amino acid differences between ants and other tax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12"/>
          <p:cNvGrpSpPr/>
          <p:nvPr/>
        </p:nvGrpSpPr>
        <p:grpSpPr>
          <a:xfrm>
            <a:off x="2187720" y="406440"/>
            <a:ext cx="4768560" cy="3840120"/>
            <a:chOff x="2187720" y="406440"/>
            <a:chExt cx="4768560" cy="3840120"/>
          </a:xfrm>
        </p:grpSpPr>
        <p:pic>
          <p:nvPicPr>
            <p:cNvPr id="47" name="Picture 2" descr=""/>
            <p:cNvPicPr/>
            <p:nvPr/>
          </p:nvPicPr>
          <p:blipFill>
            <a:blip r:embed="rId1"/>
            <a:stretch/>
          </p:blipFill>
          <p:spPr>
            <a:xfrm>
              <a:off x="2187720" y="406440"/>
              <a:ext cx="4768560" cy="384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Rectangle 9"/>
            <p:cNvSpPr/>
            <p:nvPr/>
          </p:nvSpPr>
          <p:spPr>
            <a:xfrm>
              <a:off x="5891400" y="1498680"/>
              <a:ext cx="75960" cy="525240"/>
            </a:xfrm>
            <a:prstGeom prst="rect">
              <a:avLst/>
            </a:prstGeom>
            <a:noFill/>
            <a:ln w="28440">
              <a:solidFill>
                <a:srgbClr val="4a7ebb"/>
              </a:solidFill>
              <a:round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4583160" y="2895840"/>
              <a:ext cx="75960" cy="523800"/>
            </a:xfrm>
            <a:prstGeom prst="rect">
              <a:avLst/>
            </a:prstGeom>
            <a:noFill/>
            <a:ln w="28440">
              <a:solidFill>
                <a:srgbClr val="4a7ebb"/>
              </a:solidFill>
              <a:round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1"/>
            <p:cNvSpPr/>
            <p:nvPr/>
          </p:nvSpPr>
          <p:spPr>
            <a:xfrm>
              <a:off x="4514760" y="3589560"/>
              <a:ext cx="75960" cy="525240"/>
            </a:xfrm>
            <a:prstGeom prst="rect">
              <a:avLst/>
            </a:prstGeom>
            <a:noFill/>
            <a:ln w="28440">
              <a:solidFill>
                <a:srgbClr val="4a7ebb"/>
              </a:solidFill>
              <a:round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29T02:48:47Z</dcterms:created>
  <dc:creator>Colgate University</dc:creator>
  <dc:description/>
  <dc:language>en-US</dc:language>
  <cp:lastModifiedBy>Colgate University</cp:lastModifiedBy>
  <dcterms:modified xsi:type="dcterms:W3CDTF">2011-07-21T01:12:45Z</dcterms:modified>
  <cp:revision>12</cp:revision>
  <dc:subject/>
  <dc:title>Slide 1</dc:title>
</cp:coreProperties>
</file>